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sldIdLst>
    <p:sldId id="260" r:id="rId5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megowda" initials="HV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34" autoAdjust="0"/>
  </p:normalViewPr>
  <p:slideViewPr>
    <p:cSldViewPr snapToGrid="0">
      <p:cViewPr varScale="1">
        <p:scale>
          <a:sx n="28" d="100"/>
          <a:sy n="28" d="100"/>
        </p:scale>
        <p:origin x="2274" y="114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532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178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120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388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767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223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483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016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498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252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346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7B6C6-404B-4981-9F27-BC98BFE8499D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09700-599A-4D25-BD97-B77AA5DB35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405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75732" y="7952721"/>
            <a:ext cx="11311467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verview of information presented in the review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 understand the mechanism of plant tolerance to combined stress using shared responses of plants from multiple individual stress studies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ponse of plants to individual multiple stresses.  A and B indicate two different stress conditions. R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R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icate plants responses characteristic to A and B and R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icates the shared responses to two stress conditions (Shared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ividual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pons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plants to combined stresses. The additional circle C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icates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combined stress condition. R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icates the responses unique to the combined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esses that we refer as tailored response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icates the shared responses to all three stress conditions (Shared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mbined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me shared responses can also be tailored. </a:t>
            </a:r>
            <a:r>
              <a:rPr lang="en-US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</a:t>
            </a:r>
            <a:r>
              <a:rPr lang="en-US" sz="1200" baseline="-250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R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icate the responses shared between combined stress and stress A and stress A and B, respectively.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b="41449"/>
          <a:stretch/>
        </p:blipFill>
        <p:spPr>
          <a:xfrm>
            <a:off x="1886492" y="3253681"/>
            <a:ext cx="8345913" cy="38537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4244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1.PPTX</TitleName>
    <StageName xmlns="ad5e6ac6-7e28-44ff-b599-4b096ee3745e" xsi:nil="true"/>
    <DocumentType xmlns="ad5e6ac6-7e28-44ff-b599-4b096ee3745e">Presentation</DocumentType>
    <DocumentId xmlns="ad5e6ac6-7e28-44ff-b599-4b096ee3745e">Presentation 1.PPTX</DocumentId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6E99D8B2-F12C-45BC-82CC-073C5BC4FF1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36D1EDC-6CD6-42BF-82AB-DD89FA0347F6}">
  <ds:schemaRefs>
    <ds:schemaRef ds:uri="http://www.w3.org/XML/1998/namespace"/>
    <ds:schemaRef ds:uri="http://schemas.microsoft.com/office/2006/documentManagement/types"/>
    <ds:schemaRef ds:uri="http://schemas.microsoft.com/office/2006/metadata/properties"/>
    <ds:schemaRef ds:uri="http://purl.org/dc/terms/"/>
    <ds:schemaRef ds:uri="ad5e6ac6-7e28-44ff-b599-4b096ee3745e"/>
    <ds:schemaRef ds:uri="http://purl.org/dc/dcmitype/"/>
    <ds:schemaRef ds:uri="http://purl.org/dc/elements/1.1/"/>
    <ds:schemaRef ds:uri="http://schemas.openxmlformats.org/package/2006/metadata/core-properties"/>
  </ds:schemaRefs>
</ds:datastoreItem>
</file>

<file path=customXml/itemProps3.xml><?xml version="1.0" encoding="utf-8"?>
<ds:datastoreItem xmlns:ds="http://schemas.openxmlformats.org/officeDocument/2006/customXml" ds:itemID="{FF2FC3A3-09E8-449B-B81E-C4FAB8EBEBF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d5e6ac6-7e28-44ff-b599-4b096ee3745e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6</TotalTime>
  <Words>15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41</cp:revision>
  <dcterms:created xsi:type="dcterms:W3CDTF">2015-06-03T08:23:24Z</dcterms:created>
  <dcterms:modified xsi:type="dcterms:W3CDTF">2015-08-04T01:24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